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2" d="100"/>
          <a:sy n="112" d="100"/>
        </p:scale>
        <p:origin x="55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knadibossian,Vicken" userId="31d4f4bf-0d85-4b5b-9f40-077130481317" providerId="ADAL" clId="{9FFA678A-38DB-4EB9-889E-754F4E37D48A}"/>
    <pc:docChg chg="delSld modSld">
      <pc:chgData name="Aknadibossian,Vicken" userId="31d4f4bf-0d85-4b5b-9f40-077130481317" providerId="ADAL" clId="{9FFA678A-38DB-4EB9-889E-754F4E37D48A}" dt="2023-02-08T18:16:40.665" v="15" actId="1036"/>
      <pc:docMkLst>
        <pc:docMk/>
      </pc:docMkLst>
      <pc:sldChg chg="del">
        <pc:chgData name="Aknadibossian,Vicken" userId="31d4f4bf-0d85-4b5b-9f40-077130481317" providerId="ADAL" clId="{9FFA678A-38DB-4EB9-889E-754F4E37D48A}" dt="2023-02-08T18:16:25.285" v="0" actId="47"/>
        <pc:sldMkLst>
          <pc:docMk/>
          <pc:sldMk cId="188006873" sldId="280"/>
        </pc:sldMkLst>
      </pc:sldChg>
      <pc:sldChg chg="del">
        <pc:chgData name="Aknadibossian,Vicken" userId="31d4f4bf-0d85-4b5b-9f40-077130481317" providerId="ADAL" clId="{9FFA678A-38DB-4EB9-889E-754F4E37D48A}" dt="2023-02-08T18:16:28.155" v="3" actId="47"/>
        <pc:sldMkLst>
          <pc:docMk/>
          <pc:sldMk cId="2428102584" sldId="281"/>
        </pc:sldMkLst>
      </pc:sldChg>
      <pc:sldChg chg="del">
        <pc:chgData name="Aknadibossian,Vicken" userId="31d4f4bf-0d85-4b5b-9f40-077130481317" providerId="ADAL" clId="{9FFA678A-38DB-4EB9-889E-754F4E37D48A}" dt="2023-02-08T18:16:26.605" v="1" actId="47"/>
        <pc:sldMkLst>
          <pc:docMk/>
          <pc:sldMk cId="2372919321" sldId="282"/>
        </pc:sldMkLst>
      </pc:sldChg>
      <pc:sldChg chg="del">
        <pc:chgData name="Aknadibossian,Vicken" userId="31d4f4bf-0d85-4b5b-9f40-077130481317" providerId="ADAL" clId="{9FFA678A-38DB-4EB9-889E-754F4E37D48A}" dt="2023-02-08T18:16:27.335" v="2" actId="47"/>
        <pc:sldMkLst>
          <pc:docMk/>
          <pc:sldMk cId="520136572" sldId="283"/>
        </pc:sldMkLst>
      </pc:sldChg>
      <pc:sldChg chg="modSp mod">
        <pc:chgData name="Aknadibossian,Vicken" userId="31d4f4bf-0d85-4b5b-9f40-077130481317" providerId="ADAL" clId="{9FFA678A-38DB-4EB9-889E-754F4E37D48A}" dt="2023-02-08T18:16:40.665" v="15" actId="1036"/>
        <pc:sldMkLst>
          <pc:docMk/>
          <pc:sldMk cId="3580119040" sldId="284"/>
        </pc:sldMkLst>
        <pc:spChg chg="mod">
          <ac:chgData name="Aknadibossian,Vicken" userId="31d4f4bf-0d85-4b5b-9f40-077130481317" providerId="ADAL" clId="{9FFA678A-38DB-4EB9-889E-754F4E37D48A}" dt="2023-02-08T18:16:40.665" v="15" actId="1036"/>
          <ac:spMkLst>
            <pc:docMk/>
            <pc:sldMk cId="3580119040" sldId="284"/>
            <ac:spMk id="10" creationId="{12476FD5-0E1E-4D7D-CB4B-7D5C0B37079B}"/>
          </ac:spMkLst>
        </pc:spChg>
      </pc:sldChg>
    </pc:docChg>
  </pc:docChgLst>
  <pc:docChgLst>
    <pc:chgData name="Aknadibossian,Vicken" userId="31d4f4bf-0d85-4b5b-9f40-077130481317" providerId="ADAL" clId="{3219C659-D184-45E2-BA8D-5E3B1384AE43}"/>
    <pc:docChg chg="modSld">
      <pc:chgData name="Aknadibossian,Vicken" userId="31d4f4bf-0d85-4b5b-9f40-077130481317" providerId="ADAL" clId="{3219C659-D184-45E2-BA8D-5E3B1384AE43}" dt="2023-01-27T21:05:15.417" v="249" actId="207"/>
      <pc:docMkLst>
        <pc:docMk/>
      </pc:docMkLst>
      <pc:sldChg chg="modSp mod">
        <pc:chgData name="Aknadibossian,Vicken" userId="31d4f4bf-0d85-4b5b-9f40-077130481317" providerId="ADAL" clId="{3219C659-D184-45E2-BA8D-5E3B1384AE43}" dt="2023-01-27T21:02:20.028" v="201" actId="1076"/>
        <pc:sldMkLst>
          <pc:docMk/>
          <pc:sldMk cId="188006873" sldId="280"/>
        </pc:sldMkLst>
        <pc:spChg chg="mod">
          <ac:chgData name="Aknadibossian,Vicken" userId="31d4f4bf-0d85-4b5b-9f40-077130481317" providerId="ADAL" clId="{3219C659-D184-45E2-BA8D-5E3B1384AE43}" dt="2023-01-27T21:02:20.028" v="201" actId="1076"/>
          <ac:spMkLst>
            <pc:docMk/>
            <pc:sldMk cId="188006873" sldId="280"/>
            <ac:spMk id="4" creationId="{00000000-0000-0000-0000-000000000000}"/>
          </ac:spMkLst>
        </pc:spChg>
        <pc:graphicFrameChg chg="mod">
          <ac:chgData name="Aknadibossian,Vicken" userId="31d4f4bf-0d85-4b5b-9f40-077130481317" providerId="ADAL" clId="{3219C659-D184-45E2-BA8D-5E3B1384AE43}" dt="2023-01-24T18:20:59.582" v="146" actId="20577"/>
          <ac:graphicFrameMkLst>
            <pc:docMk/>
            <pc:sldMk cId="188006873" sldId="280"/>
            <ac:graphicFrameMk id="3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04.869" v="151" actId="20577"/>
          <ac:graphicFrameMkLst>
            <pc:docMk/>
            <pc:sldMk cId="188006873" sldId="280"/>
            <ac:graphicFrameMk id="5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08.956" v="156" actId="20577"/>
          <ac:graphicFrameMkLst>
            <pc:docMk/>
            <pc:sldMk cId="188006873" sldId="280"/>
            <ac:graphicFrameMk id="6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17.030" v="161" actId="20577"/>
          <ac:graphicFrameMkLst>
            <pc:docMk/>
            <pc:sldMk cId="188006873" sldId="280"/>
            <ac:graphicFrameMk id="7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21.989" v="166" actId="20577"/>
          <ac:graphicFrameMkLst>
            <pc:docMk/>
            <pc:sldMk cId="188006873" sldId="280"/>
            <ac:graphicFrameMk id="8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26.117" v="171" actId="20577"/>
          <ac:graphicFrameMkLst>
            <pc:docMk/>
            <pc:sldMk cId="188006873" sldId="280"/>
            <ac:graphicFrameMk id="9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31.896" v="176" actId="20577"/>
          <ac:graphicFrameMkLst>
            <pc:docMk/>
            <pc:sldMk cId="188006873" sldId="280"/>
            <ac:graphicFrameMk id="10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37.290" v="181" actId="20577"/>
          <ac:graphicFrameMkLst>
            <pc:docMk/>
            <pc:sldMk cId="188006873" sldId="280"/>
            <ac:graphicFrameMk id="11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1:41.162" v="186" actId="20577"/>
          <ac:graphicFrameMkLst>
            <pc:docMk/>
            <pc:sldMk cId="188006873" sldId="280"/>
            <ac:graphicFrameMk id="12" creationId="{00000000-0000-0000-0000-000000000000}"/>
          </ac:graphicFrameMkLst>
        </pc:graphicFrameChg>
      </pc:sldChg>
      <pc:sldChg chg="modSp mod">
        <pc:chgData name="Aknadibossian,Vicken" userId="31d4f4bf-0d85-4b5b-9f40-077130481317" providerId="ADAL" clId="{3219C659-D184-45E2-BA8D-5E3B1384AE43}" dt="2023-01-27T21:01:51.148" v="196" actId="255"/>
        <pc:sldMkLst>
          <pc:docMk/>
          <pc:sldMk cId="2428102584" sldId="281"/>
        </pc:sldMkLst>
        <pc:spChg chg="mod">
          <ac:chgData name="Aknadibossian,Vicken" userId="31d4f4bf-0d85-4b5b-9f40-077130481317" providerId="ADAL" clId="{3219C659-D184-45E2-BA8D-5E3B1384AE43}" dt="2023-01-27T21:01:51.148" v="196" actId="255"/>
          <ac:spMkLst>
            <pc:docMk/>
            <pc:sldMk cId="2428102584" sldId="281"/>
            <ac:spMk id="2" creationId="{00000000-0000-0000-0000-000000000000}"/>
          </ac:spMkLst>
        </pc:spChg>
        <pc:graphicFrameChg chg="mod">
          <ac:chgData name="Aknadibossian,Vicken" userId="31d4f4bf-0d85-4b5b-9f40-077130481317" providerId="ADAL" clId="{3219C659-D184-45E2-BA8D-5E3B1384AE43}" dt="2023-01-24T18:17:36.479" v="16" actId="20577"/>
          <ac:graphicFrameMkLst>
            <pc:docMk/>
            <pc:sldMk cId="2428102584" sldId="281"/>
            <ac:graphicFrameMk id="3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7:43.390" v="21" actId="20577"/>
          <ac:graphicFrameMkLst>
            <pc:docMk/>
            <pc:sldMk cId="2428102584" sldId="281"/>
            <ac:graphicFrameMk id="4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7:48.620" v="26" actId="20577"/>
          <ac:graphicFrameMkLst>
            <pc:docMk/>
            <pc:sldMk cId="2428102584" sldId="281"/>
            <ac:graphicFrameMk id="5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8:10.423" v="33" actId="20577"/>
          <ac:graphicFrameMkLst>
            <pc:docMk/>
            <pc:sldMk cId="2428102584" sldId="281"/>
            <ac:graphicFrameMk id="6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8:17.756" v="40" actId="20577"/>
          <ac:graphicFrameMkLst>
            <pc:docMk/>
            <pc:sldMk cId="2428102584" sldId="281"/>
            <ac:graphicFrameMk id="7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8:22.861" v="47" actId="20577"/>
          <ac:graphicFrameMkLst>
            <pc:docMk/>
            <pc:sldMk cId="2428102584" sldId="281"/>
            <ac:graphicFrameMk id="8" creationId="{00000000-0000-0000-0000-000000000000}"/>
          </ac:graphicFrameMkLst>
        </pc:graphicFrameChg>
      </pc:sldChg>
      <pc:sldChg chg="modSp mod">
        <pc:chgData name="Aknadibossian,Vicken" userId="31d4f4bf-0d85-4b5b-9f40-077130481317" providerId="ADAL" clId="{3219C659-D184-45E2-BA8D-5E3B1384AE43}" dt="2023-01-27T21:01:37.999" v="192" actId="255"/>
        <pc:sldMkLst>
          <pc:docMk/>
          <pc:sldMk cId="2372919321" sldId="282"/>
        </pc:sldMkLst>
        <pc:spChg chg="mod">
          <ac:chgData name="Aknadibossian,Vicken" userId="31d4f4bf-0d85-4b5b-9f40-077130481317" providerId="ADAL" clId="{3219C659-D184-45E2-BA8D-5E3B1384AE43}" dt="2023-01-27T21:01:37.999" v="192" actId="255"/>
          <ac:spMkLst>
            <pc:docMk/>
            <pc:sldMk cId="2372919321" sldId="282"/>
            <ac:spMk id="2" creationId="{00000000-0000-0000-0000-000000000000}"/>
          </ac:spMkLst>
        </pc:spChg>
        <pc:graphicFrameChg chg="mod">
          <ac:chgData name="Aknadibossian,Vicken" userId="31d4f4bf-0d85-4b5b-9f40-077130481317" providerId="ADAL" clId="{3219C659-D184-45E2-BA8D-5E3B1384AE43}" dt="2023-01-24T18:19:34.829" v="99" actId="20577"/>
          <ac:graphicFrameMkLst>
            <pc:docMk/>
            <pc:sldMk cId="2372919321" sldId="282"/>
            <ac:graphicFrameMk id="3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39.698" v="104" actId="20577"/>
          <ac:graphicFrameMkLst>
            <pc:docMk/>
            <pc:sldMk cId="2372919321" sldId="282"/>
            <ac:graphicFrameMk id="4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43.751" v="109" actId="20577"/>
          <ac:graphicFrameMkLst>
            <pc:docMk/>
            <pc:sldMk cId="2372919321" sldId="282"/>
            <ac:graphicFrameMk id="5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48.138" v="114" actId="20577"/>
          <ac:graphicFrameMkLst>
            <pc:docMk/>
            <pc:sldMk cId="2372919321" sldId="282"/>
            <ac:graphicFrameMk id="6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53.159" v="119" actId="20577"/>
          <ac:graphicFrameMkLst>
            <pc:docMk/>
            <pc:sldMk cId="2372919321" sldId="282"/>
            <ac:graphicFrameMk id="7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0:03.781" v="126" actId="20577"/>
          <ac:graphicFrameMkLst>
            <pc:docMk/>
            <pc:sldMk cId="2372919321" sldId="282"/>
            <ac:graphicFrameMk id="8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0:10.806" v="131" actId="20577"/>
          <ac:graphicFrameMkLst>
            <pc:docMk/>
            <pc:sldMk cId="2372919321" sldId="282"/>
            <ac:graphicFrameMk id="9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0:17.083" v="136" actId="20577"/>
          <ac:graphicFrameMkLst>
            <pc:docMk/>
            <pc:sldMk cId="2372919321" sldId="282"/>
            <ac:graphicFrameMk id="10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20:22.048" v="141" actId="20577"/>
          <ac:graphicFrameMkLst>
            <pc:docMk/>
            <pc:sldMk cId="2372919321" sldId="282"/>
            <ac:graphicFrameMk id="11" creationId="{00000000-0000-0000-0000-000000000000}"/>
          </ac:graphicFrameMkLst>
        </pc:graphicFrameChg>
      </pc:sldChg>
      <pc:sldChg chg="modSp mod">
        <pc:chgData name="Aknadibossian,Vicken" userId="31d4f4bf-0d85-4b5b-9f40-077130481317" providerId="ADAL" clId="{3219C659-D184-45E2-BA8D-5E3B1384AE43}" dt="2023-01-27T21:01:44.563" v="194" actId="255"/>
        <pc:sldMkLst>
          <pc:docMk/>
          <pc:sldMk cId="520136572" sldId="283"/>
        </pc:sldMkLst>
        <pc:spChg chg="mod">
          <ac:chgData name="Aknadibossian,Vicken" userId="31d4f4bf-0d85-4b5b-9f40-077130481317" providerId="ADAL" clId="{3219C659-D184-45E2-BA8D-5E3B1384AE43}" dt="2023-01-27T21:01:44.563" v="194" actId="255"/>
          <ac:spMkLst>
            <pc:docMk/>
            <pc:sldMk cId="520136572" sldId="283"/>
            <ac:spMk id="2" creationId="{00000000-0000-0000-0000-000000000000}"/>
          </ac:spMkLst>
        </pc:spChg>
        <pc:graphicFrameChg chg="mod">
          <ac:chgData name="Aknadibossian,Vicken" userId="31d4f4bf-0d85-4b5b-9f40-077130481317" providerId="ADAL" clId="{3219C659-D184-45E2-BA8D-5E3B1384AE43}" dt="2023-01-24T18:18:36.507" v="52" actId="20577"/>
          <ac:graphicFrameMkLst>
            <pc:docMk/>
            <pc:sldMk cId="520136572" sldId="283"/>
            <ac:graphicFrameMk id="4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8:45.572" v="59" actId="20577"/>
          <ac:graphicFrameMkLst>
            <pc:docMk/>
            <pc:sldMk cId="520136572" sldId="283"/>
            <ac:graphicFrameMk id="5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8:51.686" v="64" actId="20577"/>
          <ac:graphicFrameMkLst>
            <pc:docMk/>
            <pc:sldMk cId="520136572" sldId="283"/>
            <ac:graphicFrameMk id="6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8:57.502" v="69" actId="20577"/>
          <ac:graphicFrameMkLst>
            <pc:docMk/>
            <pc:sldMk cId="520136572" sldId="283"/>
            <ac:graphicFrameMk id="8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01.260" v="74" actId="20577"/>
          <ac:graphicFrameMkLst>
            <pc:docMk/>
            <pc:sldMk cId="520136572" sldId="283"/>
            <ac:graphicFrameMk id="9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06.277" v="79" actId="20577"/>
          <ac:graphicFrameMkLst>
            <pc:docMk/>
            <pc:sldMk cId="520136572" sldId="283"/>
            <ac:graphicFrameMk id="10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11.344" v="82" actId="20577"/>
          <ac:graphicFrameMkLst>
            <pc:docMk/>
            <pc:sldMk cId="520136572" sldId="283"/>
            <ac:graphicFrameMk id="12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21.733" v="89" actId="20577"/>
          <ac:graphicFrameMkLst>
            <pc:docMk/>
            <pc:sldMk cId="520136572" sldId="283"/>
            <ac:graphicFrameMk id="13" creationId="{00000000-0000-0000-0000-000000000000}"/>
          </ac:graphicFrameMkLst>
        </pc:graphicFrameChg>
        <pc:graphicFrameChg chg="mod">
          <ac:chgData name="Aknadibossian,Vicken" userId="31d4f4bf-0d85-4b5b-9f40-077130481317" providerId="ADAL" clId="{3219C659-D184-45E2-BA8D-5E3B1384AE43}" dt="2023-01-24T18:19:26.120" v="94" actId="20577"/>
          <ac:graphicFrameMkLst>
            <pc:docMk/>
            <pc:sldMk cId="520136572" sldId="283"/>
            <ac:graphicFrameMk id="15" creationId="{00000000-0000-0000-0000-000000000000}"/>
          </ac:graphicFrameMkLst>
        </pc:graphicFrameChg>
      </pc:sldChg>
      <pc:sldChg chg="addSp modSp mod">
        <pc:chgData name="Aknadibossian,Vicken" userId="31d4f4bf-0d85-4b5b-9f40-077130481317" providerId="ADAL" clId="{3219C659-D184-45E2-BA8D-5E3B1384AE43}" dt="2023-01-27T21:05:15.417" v="249" actId="207"/>
        <pc:sldMkLst>
          <pc:docMk/>
          <pc:sldMk cId="3580119040" sldId="284"/>
        </pc:sldMkLst>
        <pc:spChg chg="mod">
          <ac:chgData name="Aknadibossian,Vicken" userId="31d4f4bf-0d85-4b5b-9f40-077130481317" providerId="ADAL" clId="{3219C659-D184-45E2-BA8D-5E3B1384AE43}" dt="2023-01-27T21:05:15.417" v="249" actId="207"/>
          <ac:spMkLst>
            <pc:docMk/>
            <pc:sldMk cId="3580119040" sldId="284"/>
            <ac:spMk id="2" creationId="{2A080466-8B2C-49B4-BDCF-38B6DC6708F2}"/>
          </ac:spMkLst>
        </pc:spChg>
        <pc:spChg chg="add mod">
          <ac:chgData name="Aknadibossian,Vicken" userId="31d4f4bf-0d85-4b5b-9f40-077130481317" providerId="ADAL" clId="{3219C659-D184-45E2-BA8D-5E3B1384AE43}" dt="2023-01-27T21:04:29.565" v="239" actId="1076"/>
          <ac:spMkLst>
            <pc:docMk/>
            <pc:sldMk cId="3580119040" sldId="284"/>
            <ac:spMk id="7" creationId="{6664F6CA-7CF8-303D-2577-81977590A871}"/>
          </ac:spMkLst>
        </pc:spChg>
        <pc:spChg chg="add mod">
          <ac:chgData name="Aknadibossian,Vicken" userId="31d4f4bf-0d85-4b5b-9f40-077130481317" providerId="ADAL" clId="{3219C659-D184-45E2-BA8D-5E3B1384AE43}" dt="2023-01-27T21:04:36.392" v="242" actId="20577"/>
          <ac:spMkLst>
            <pc:docMk/>
            <pc:sldMk cId="3580119040" sldId="284"/>
            <ac:spMk id="8" creationId="{893B2D93-7EC0-1DF7-590F-74ACB572861C}"/>
          </ac:spMkLst>
        </pc:spChg>
        <pc:spChg chg="add mod">
          <ac:chgData name="Aknadibossian,Vicken" userId="31d4f4bf-0d85-4b5b-9f40-077130481317" providerId="ADAL" clId="{3219C659-D184-45E2-BA8D-5E3B1384AE43}" dt="2023-01-27T21:04:45.005" v="245" actId="20577"/>
          <ac:spMkLst>
            <pc:docMk/>
            <pc:sldMk cId="3580119040" sldId="284"/>
            <ac:spMk id="9" creationId="{1DE4B754-57F9-77B2-99C8-563B91CB8A7B}"/>
          </ac:spMkLst>
        </pc:spChg>
        <pc:spChg chg="add mod">
          <ac:chgData name="Aknadibossian,Vicken" userId="31d4f4bf-0d85-4b5b-9f40-077130481317" providerId="ADAL" clId="{3219C659-D184-45E2-BA8D-5E3B1384AE43}" dt="2023-01-27T21:04:51.390" v="248" actId="20577"/>
          <ac:spMkLst>
            <pc:docMk/>
            <pc:sldMk cId="3580119040" sldId="284"/>
            <ac:spMk id="10" creationId="{12476FD5-0E1E-4D7D-CB4B-7D5C0B37079B}"/>
          </ac:spMkLst>
        </pc:spChg>
        <pc:picChg chg="add mod">
          <ac:chgData name="Aknadibossian,Vicken" userId="31d4f4bf-0d85-4b5b-9f40-077130481317" providerId="ADAL" clId="{3219C659-D184-45E2-BA8D-5E3B1384AE43}" dt="2023-01-27T21:03:51.623" v="226" actId="14100"/>
          <ac:picMkLst>
            <pc:docMk/>
            <pc:sldMk cId="3580119040" sldId="284"/>
            <ac:picMk id="3" creationId="{B8BDD10D-0053-7C96-EE42-422A75140634}"/>
          </ac:picMkLst>
        </pc:picChg>
        <pc:picChg chg="add mod">
          <ac:chgData name="Aknadibossian,Vicken" userId="31d4f4bf-0d85-4b5b-9f40-077130481317" providerId="ADAL" clId="{3219C659-D184-45E2-BA8D-5E3B1384AE43}" dt="2023-01-27T21:03:58.665" v="229" actId="14100"/>
          <ac:picMkLst>
            <pc:docMk/>
            <pc:sldMk cId="3580119040" sldId="284"/>
            <ac:picMk id="4" creationId="{52AB0FB8-1DF2-2451-CBFB-6E9B5915674F}"/>
          </ac:picMkLst>
        </pc:picChg>
        <pc:picChg chg="add mod">
          <ac:chgData name="Aknadibossian,Vicken" userId="31d4f4bf-0d85-4b5b-9f40-077130481317" providerId="ADAL" clId="{3219C659-D184-45E2-BA8D-5E3B1384AE43}" dt="2023-01-27T21:04:01.484" v="230" actId="14100"/>
          <ac:picMkLst>
            <pc:docMk/>
            <pc:sldMk cId="3580119040" sldId="284"/>
            <ac:picMk id="5" creationId="{90D5AD7B-ED79-F623-5251-E829A2793707}"/>
          </ac:picMkLst>
        </pc:picChg>
        <pc:picChg chg="add mod">
          <ac:chgData name="Aknadibossian,Vicken" userId="31d4f4bf-0d85-4b5b-9f40-077130481317" providerId="ADAL" clId="{3219C659-D184-45E2-BA8D-5E3B1384AE43}" dt="2023-01-27T21:04:05.442" v="232" actId="1076"/>
          <ac:picMkLst>
            <pc:docMk/>
            <pc:sldMk cId="3580119040" sldId="284"/>
            <ac:picMk id="6" creationId="{4E8FB9EF-ABA1-D9F7-44DE-88A06760A91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964A7-0445-4FC3-9D16-54DF56FF4A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027663-4F38-4109-A2A3-B841CA53CE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C5A452-4670-42C5-A43D-49EA3794F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E19E51-8A86-4D8C-A936-E20A72C62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B3BA45-9485-4936-8680-229DD4828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721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A42458-213C-44FC-8522-02DCBFEB17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6EA565-9317-4585-957C-0BD252B635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977F83-DAC2-4517-900D-FAAAE93BA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C02D78-783A-4BAF-85BA-B1F0DF13E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9C6A-3E89-40FE-B06C-3685E961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267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D5DEAF-267C-4525-B73A-B4DA18DB66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2104BE-964B-4CDC-B412-CC41101E21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6C024B-5EA3-4BBE-9900-7E1DE8375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E00EEB-E492-4FCB-89D1-D60F5A9099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5B8474-3473-4A0D-B67A-2150D1E9A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576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F4660-03DF-48C6-95FE-87C7743CA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E6B8E2-E0F0-4DE4-ABEB-39F79AB147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112939-F2F3-4806-8912-3156DC75F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FBCDDE-74BE-4FA4-824A-902C19857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598251-534A-4203-B095-94E6CD91B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078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404A8-6904-4B81-B868-BFFAE82633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76AF4F-E7A4-4323-B35A-2F15028D6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F3C779-75F2-4783-B702-5A423A315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DB8A94-F8F2-4ACF-8124-92F180E5D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BC4A4-902A-4EF1-AEE4-F7B5CCEA0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845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DA36E7-1542-4815-BFE6-AFCF1335A9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BACBAF-260D-408E-B12F-3120B9CA8C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8186B0-11E4-4E43-82D5-4AAAF19DF9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3B6825-CA15-445F-A1F6-9F38B6D3C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719658-4A89-409F-88FA-6E8B66B8F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4D1C0C-EC06-4F7B-85C7-7516E2C6B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693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322B7-82AF-4AD4-A6C7-EC7BBE7A94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6C1D46-7E48-409F-9E67-42C398B06D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CF65CA-4955-480B-A108-01E07544CC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0AEE01-BDAF-40BB-9C10-88A17CC1A5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8B2DBE-C7DE-499A-9891-8C756440E1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15CFD5-8801-44D5-87F5-4AC013E5A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ED8AFC-F9D2-4C6E-B355-D5CC23773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6750EA-E83D-41CB-9791-9E31569A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3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467CF-1867-4AD0-9318-540DF10039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CAA1CD-8117-4AD4-9671-586838DB7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D03A84F-1B61-4424-AC67-1E331B817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E2AB8C-66EC-4385-B61E-7E4E0C2B4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127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6DB45B-5105-4E25-B081-A1ED561F3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151ED1-DFA3-4923-AD82-C8839BE45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5D8C51-549C-4351-ADBF-0D5230760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027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B7B472-3CE8-4A44-B233-2EB72646E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D30997-9FB3-4DCE-9CC4-57D69C94CB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A9AD66-3AC4-4A91-9760-E3CE7C2637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05612A-160C-4D62-A597-ABC5B9F97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4F3BFF-DE5D-4264-93BF-FA74D8B15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3B679E-FDDC-428C-9427-5A57C539F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384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FBAA19-C9DB-4BFC-8BAD-FDD5ACE5E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E74C9A-4592-4967-B340-98816C2245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AFC2F7-4223-45E1-9A9F-CDACFA02C9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080354-DF56-4FBB-A67E-F1A368140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96864B-9FA8-40F6-9762-30D83024C2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7052A1-4D68-43CF-8733-88C1E2078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250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FA5E94-43FD-4460-8921-5AB02BF63E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77E98F-0355-417C-B591-7A1A0ABD5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AABF1D-774C-4AB7-8C93-77659913DD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ED9D5-CCF5-4CF0-8DBE-C273624D4871}" type="datetimeFigureOut">
              <a:rPr lang="en-US" smtClean="0"/>
              <a:t>2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699153-0258-45FE-B0E1-838AB833E8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751E89-96C8-4E17-B383-AAF28C30F1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88EC45-E8FA-4BAA-9E31-A0944BC34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074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080466-8B2C-49B4-BDCF-38B6DC6708F2}"/>
              </a:ext>
            </a:extLst>
          </p:cNvPr>
          <p:cNvSpPr txBox="1"/>
          <p:nvPr/>
        </p:nvSpPr>
        <p:spPr>
          <a:xfrm>
            <a:off x="0" y="6303946"/>
            <a:ext cx="120849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-class profles of total, sense (forward) and antisense (reverse) small RNA reads from mock-inoculated and CTV T36- or T68-1-infected </a:t>
            </a:r>
            <a:r>
              <a:rPr lang="de-CH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trus sinensis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mapped with zero mismatches to the reference sequences of the </a:t>
            </a:r>
            <a:r>
              <a:rPr lang="de-CH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trus sinensis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(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chloroplast (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itochondrion (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TV (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enomes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8BDD10D-0053-7C96-EE42-422A751406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4219" y="203731"/>
            <a:ext cx="4494904" cy="288089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2AB0FB8-1DF2-2451-CBFB-6E9B591567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03732"/>
            <a:ext cx="4502771" cy="292411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0D5AD7B-ED79-F623-5251-E829A27937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2083" y="3296603"/>
            <a:ext cx="4242488" cy="275211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E8FB9EF-ABA1-D9F7-44DE-88A06760A9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14182" y="3429000"/>
            <a:ext cx="3271843" cy="251660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664F6CA-7CF8-303D-2577-81977590A871}"/>
              </a:ext>
            </a:extLst>
          </p:cNvPr>
          <p:cNvSpPr txBox="1"/>
          <p:nvPr/>
        </p:nvSpPr>
        <p:spPr>
          <a:xfrm>
            <a:off x="437019" y="20373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93B2D93-7EC0-1DF7-590F-74ACB572861C}"/>
              </a:ext>
            </a:extLst>
          </p:cNvPr>
          <p:cNvSpPr txBox="1"/>
          <p:nvPr/>
        </p:nvSpPr>
        <p:spPr>
          <a:xfrm>
            <a:off x="5657530" y="20373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DE4B754-57F9-77B2-99C8-563B91CB8A7B}"/>
              </a:ext>
            </a:extLst>
          </p:cNvPr>
          <p:cNvSpPr txBox="1"/>
          <p:nvPr/>
        </p:nvSpPr>
        <p:spPr>
          <a:xfrm>
            <a:off x="408369" y="306917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476FD5-0E1E-4D7D-CB4B-7D5C0B37079B}"/>
              </a:ext>
            </a:extLst>
          </p:cNvPr>
          <p:cNvSpPr txBox="1"/>
          <p:nvPr/>
        </p:nvSpPr>
        <p:spPr>
          <a:xfrm>
            <a:off x="5677819" y="312565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580119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1</TotalTime>
  <Words>6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nadibossian,Vicken</dc:creator>
  <cp:lastModifiedBy>Aknadibossian,Vicken</cp:lastModifiedBy>
  <cp:revision>69</cp:revision>
  <dcterms:created xsi:type="dcterms:W3CDTF">2020-08-27T03:52:55Z</dcterms:created>
  <dcterms:modified xsi:type="dcterms:W3CDTF">2023-02-08T18:16:44Z</dcterms:modified>
</cp:coreProperties>
</file>